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856" autoAdjust="0"/>
    <p:restoredTop sz="94660"/>
  </p:normalViewPr>
  <p:slideViewPr>
    <p:cSldViewPr snapToGrid="0">
      <p:cViewPr varScale="1">
        <p:scale>
          <a:sx n="96" d="100"/>
          <a:sy n="96" d="100"/>
        </p:scale>
        <p:origin x="184" y="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DC3C00-B12E-4626-853B-2761FB74C3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6A6D59B-DAF1-4410-BB4B-11B6542073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3D16D4-3D9E-452B-8A01-798ECD9296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03234-7334-4217-815E-F6978985D230}" type="datetimeFigureOut">
              <a:rPr lang="en-US" smtClean="0"/>
              <a:t>12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984563-BEFF-4333-8B87-480D1DDA8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63E1D9-CB46-4A7A-981E-BF692857D7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CF8BB-3736-4F96-B199-F6EF3BB9B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4947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D83493-C139-4FE5-9CA7-A81BFF657D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729DCA-E2EC-43F9-960D-D7550B40D3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25DA80-AB56-4752-8128-5E235B4A1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03234-7334-4217-815E-F6978985D230}" type="datetimeFigureOut">
              <a:rPr lang="en-US" smtClean="0"/>
              <a:t>12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232100-C593-47CD-AEE5-42BA480708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5ED9FB-C018-4FC5-9693-AA56AB10DA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CF8BB-3736-4F96-B199-F6EF3BB9B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5036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6676596-DD2A-4498-A6CC-EF79C6CB5E2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09B7A0-1667-44E8-9D56-C663FD3EAF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AA2DAD-4A9F-4C43-AF55-4C9CF608B8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03234-7334-4217-815E-F6978985D230}" type="datetimeFigureOut">
              <a:rPr lang="en-US" smtClean="0"/>
              <a:t>12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7538E1-FAAE-47F5-97A3-3C43D48BD1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66E0D7-AEF7-47F4-8DAE-2A774ED2C4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CF8BB-3736-4F96-B199-F6EF3BB9B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573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CACF67-F548-484C-837D-D90DECA55C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F73E3D-C840-465B-A001-B748E2B3A5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A0239C-F594-482D-9F4D-ABF3AC11CD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03234-7334-4217-815E-F6978985D230}" type="datetimeFigureOut">
              <a:rPr lang="en-US" smtClean="0"/>
              <a:t>12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14502F-1C87-4D1A-BE41-D9385DBDB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387E57-CDF0-4F66-97A5-2DF69CB82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CF8BB-3736-4F96-B199-F6EF3BB9B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391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E43009-5A9E-4203-81AF-05E7ADF827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03DF76-6F1C-470C-B3C2-3E58760171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F52669-C507-47DF-B1E5-12DF1091D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03234-7334-4217-815E-F6978985D230}" type="datetimeFigureOut">
              <a:rPr lang="en-US" smtClean="0"/>
              <a:t>12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A1A4AE-12F0-49B5-AA89-D97C445F6C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FCFC07-011E-4A02-8A03-7D7322E55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CF8BB-3736-4F96-B199-F6EF3BB9B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99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169B5B-0B7B-40F7-B889-FB904183F0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2D6F55-4492-48C4-B2C2-B80331AE71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3C141B-2182-4B7C-8589-34EB66BE3C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269E95-3C08-4EE0-84A8-4CC1A425C9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03234-7334-4217-815E-F6978985D230}" type="datetimeFigureOut">
              <a:rPr lang="en-US" smtClean="0"/>
              <a:t>12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96C9EB-8486-4C06-99DD-7CDA680274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A885EC-BC1A-4F0B-88A1-E4357CC3A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CF8BB-3736-4F96-B199-F6EF3BB9B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556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62BE86-0E8E-4798-B7A8-A78189D39D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E83EEF-B0FD-4F78-B6F5-909C611596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299C4F-1D73-4ACF-A771-9AAB92B3D4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CE9284-8C37-4EE6-959D-ED45D5297A2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44C675-1850-4BD4-A56C-CC70A6D572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5A79E76-6D9E-4971-A996-791F5B606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03234-7334-4217-815E-F6978985D230}" type="datetimeFigureOut">
              <a:rPr lang="en-US" smtClean="0"/>
              <a:t>12/2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2F7D6F3-BA67-4E8D-A1DC-B3AF64C0DB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1D9B12E-CEAB-436E-9C92-B828F7285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CF8BB-3736-4F96-B199-F6EF3BB9B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042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DF3D13-85AB-46D9-BFA1-CF78AA7428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9DC119-E390-418F-8970-A627AD13D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03234-7334-4217-815E-F6978985D230}" type="datetimeFigureOut">
              <a:rPr lang="en-US" smtClean="0"/>
              <a:t>12/2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9FCF7B6-6698-4BD7-89C2-291FBAD5C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A5F24CA-0B4C-47F3-A483-6F6DFA9E98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CF8BB-3736-4F96-B199-F6EF3BB9B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6099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83CBD48-8304-40F4-BBEC-D442B18F83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03234-7334-4217-815E-F6978985D230}" type="datetimeFigureOut">
              <a:rPr lang="en-US" smtClean="0"/>
              <a:t>12/2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B636B3A-82D7-4C18-8202-AB75FDF92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AC58D05-C4A3-4E1B-B434-59EDFD3E6A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CF8BB-3736-4F96-B199-F6EF3BB9B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218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8CA656-FEA2-49E1-BE22-D999AD93DD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8514E9-77ED-4BD9-A273-BC74D44701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F5C31D-DDE0-44E8-BCD6-F9AD3CD1D1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F163BD-7744-4115-BAAE-440EA2B91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03234-7334-4217-815E-F6978985D230}" type="datetimeFigureOut">
              <a:rPr lang="en-US" smtClean="0"/>
              <a:t>12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51BDC1-A4E9-4CE8-8ED7-B49133398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5653FA-12D7-4F54-A8BD-4A01BD172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CF8BB-3736-4F96-B199-F6EF3BB9B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364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9DC90F-C36D-48E9-AFF1-5613317642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BA43506-4D50-4788-9DD0-AEF6410572E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B7711B-1F30-49C0-9E09-70395256E2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88F6CA-9D8E-4379-B9DB-DCE39840B3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03234-7334-4217-815E-F6978985D230}" type="datetimeFigureOut">
              <a:rPr lang="en-US" smtClean="0"/>
              <a:t>12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529C28-28CC-4B06-A8E5-650ACDD81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3FE79E-D61B-4FD1-9B93-A6AED0648A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CF8BB-3736-4F96-B199-F6EF3BB9B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492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CB49B1-057D-48D8-AF15-E9984E8934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BD90D4-4EB9-40B1-8E1C-6EB7329DC6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399324-9CE7-4008-8054-77465401910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E03234-7334-4217-815E-F6978985D230}" type="datetimeFigureOut">
              <a:rPr lang="en-US" smtClean="0"/>
              <a:t>12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58D5C3-8E47-45A6-93B4-C051ED73BA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D8A16C-C5EA-41FB-B410-4871D417A00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4CF8BB-3736-4F96-B199-F6EF3BB9B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90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2" Type="http://schemas.microsoft.com/office/2007/relationships/media" Target="../media/media1.mp4"/><Relationship Id="rId1" Type="http://schemas.openxmlformats.org/officeDocument/2006/relationships/video" Target="NULL" TargetMode="External"/><Relationship Id="rId6" Type="http://schemas.openxmlformats.org/officeDocument/2006/relationships/image" Target="../media/image2.png"/><Relationship Id="rId5" Type="http://schemas.openxmlformats.org/officeDocument/2006/relationships/image" Target="../media/image1.png"/><Relationship Id="rId4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Screen Recording 3">
            <a:hlinkClick r:id="" action="ppaction://media"/>
            <a:extLst>
              <a:ext uri="{FF2B5EF4-FFF2-40B4-BE49-F238E27FC236}">
                <a16:creationId xmlns:a16="http://schemas.microsoft.com/office/drawing/2014/main" id="{620C366F-7F92-4298-8F88-D0CCABB9E3C2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2">
                  <p14:trim st="7394" end="2906"/>
                </p14:media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28600" y="109730"/>
            <a:ext cx="4526280" cy="529698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4C45C12-3DAE-48B1-892A-B58440D79003}"/>
              </a:ext>
            </a:extLst>
          </p:cNvPr>
          <p:cNvSpPr txBox="1"/>
          <p:nvPr/>
        </p:nvSpPr>
        <p:spPr>
          <a:xfrm>
            <a:off x="228600" y="5562934"/>
            <a:ext cx="1147071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26-year-old female patient with a confirmed diagnosis of Crohn's disease underwent Cine-MRI (</a:t>
            </a:r>
            <a:r>
              <a:rPr lang="en-GB" dirty="0"/>
              <a:t>BTFE</a:t>
            </a:r>
            <a:r>
              <a:rPr lang="en-SA"/>
              <a:t> sequence)</a:t>
            </a:r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ns were acquired at two timepoints: prior to the initiation of treatment (baseline, left) and following a 6-month therapeutic intervention (follow-up, right).</a:t>
            </a:r>
            <a:r>
              <a:rPr lang="en-SA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se videos are courtesy from the MOTILITY trial data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Screen Recording 6">
            <a:hlinkClick r:id="" action="ppaction://media"/>
            <a:extLst>
              <a:ext uri="{FF2B5EF4-FFF2-40B4-BE49-F238E27FC236}">
                <a16:creationId xmlns:a16="http://schemas.microsoft.com/office/drawing/2014/main" id="{33B255B1-5193-49F3-AD22-FC426EEA9B08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3">
                  <p14:trim st="8769"/>
                </p14:media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4897693" y="109730"/>
            <a:ext cx="4383467" cy="52969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61414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2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993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7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57</Words>
  <Application>Microsoft Macintosh PowerPoint</Application>
  <PresentationFormat>Widescreen</PresentationFormat>
  <Paragraphs>1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 Al Mansour</dc:creator>
  <cp:lastModifiedBy>Ali Alyami</cp:lastModifiedBy>
  <cp:revision>8</cp:revision>
  <dcterms:created xsi:type="dcterms:W3CDTF">2025-11-19T13:51:54Z</dcterms:created>
  <dcterms:modified xsi:type="dcterms:W3CDTF">2025-12-02T16:49:55Z</dcterms:modified>
</cp:coreProperties>
</file>